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22475"/>
    <a:srgbClr val="DDD0DE"/>
    <a:srgbClr val="95459B"/>
    <a:srgbClr val="928DDA"/>
    <a:srgbClr val="ACA7FE"/>
    <a:srgbClr val="FCE1E6"/>
    <a:srgbClr val="FEF1F3"/>
    <a:srgbClr val="F7BDCB"/>
    <a:srgbClr val="66E2FA"/>
    <a:srgbClr val="CE9B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89"/>
    <p:restoredTop sz="77734"/>
  </p:normalViewPr>
  <p:slideViewPr>
    <p:cSldViewPr snapToGrid="0">
      <p:cViewPr varScale="1">
        <p:scale>
          <a:sx n="84" d="100"/>
          <a:sy n="84" d="100"/>
        </p:scale>
        <p:origin x="22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bastian Suarez" userId="c52542867e5c9ea9" providerId="LiveId" clId="{5D54F2F7-37EB-9E44-A1F3-9635274EB662}"/>
    <pc:docChg chg="undo custSel modSld">
      <pc:chgData name="Sebastian Suarez" userId="c52542867e5c9ea9" providerId="LiveId" clId="{5D54F2F7-37EB-9E44-A1F3-9635274EB662}" dt="2024-11-09T00:26:04.989" v="913" actId="20577"/>
      <pc:docMkLst>
        <pc:docMk/>
      </pc:docMkLst>
      <pc:sldChg chg="addSp delSp modSp mod">
        <pc:chgData name="Sebastian Suarez" userId="c52542867e5c9ea9" providerId="LiveId" clId="{5D54F2F7-37EB-9E44-A1F3-9635274EB662}" dt="2024-11-09T00:26:04.989" v="913" actId="20577"/>
        <pc:sldMkLst>
          <pc:docMk/>
          <pc:sldMk cId="1898814079" sldId="256"/>
        </pc:sldMkLst>
        <pc:spChg chg="add mod">
          <ac:chgData name="Sebastian Suarez" userId="c52542867e5c9ea9" providerId="LiveId" clId="{5D54F2F7-37EB-9E44-A1F3-9635274EB662}" dt="2024-11-09T00:23:17.024" v="695" actId="1035"/>
          <ac:spMkLst>
            <pc:docMk/>
            <pc:sldMk cId="1898814079" sldId="256"/>
            <ac:spMk id="2" creationId="{60B465EB-A2EB-0FEE-4F2A-A4FC87DEAD95}"/>
          </ac:spMkLst>
        </pc:spChg>
        <pc:spChg chg="mod">
          <ac:chgData name="Sebastian Suarez" userId="c52542867e5c9ea9" providerId="LiveId" clId="{5D54F2F7-37EB-9E44-A1F3-9635274EB662}" dt="2024-11-09T00:26:04.989" v="913" actId="20577"/>
          <ac:spMkLst>
            <pc:docMk/>
            <pc:sldMk cId="1898814079" sldId="256"/>
            <ac:spMk id="38" creationId="{ECEACCFE-F99E-8280-D1F6-9349A1B5303E}"/>
          </ac:spMkLst>
        </pc:spChg>
        <pc:spChg chg="mod">
          <ac:chgData name="Sebastian Suarez" userId="c52542867e5c9ea9" providerId="LiveId" clId="{5D54F2F7-37EB-9E44-A1F3-9635274EB662}" dt="2024-11-09T00:24:10.254" v="735" actId="1036"/>
          <ac:spMkLst>
            <pc:docMk/>
            <pc:sldMk cId="1898814079" sldId="256"/>
            <ac:spMk id="40" creationId="{FE58AED9-BD85-B91E-81F8-3CD80742E897}"/>
          </ac:spMkLst>
        </pc:spChg>
        <pc:spChg chg="mod">
          <ac:chgData name="Sebastian Suarez" userId="c52542867e5c9ea9" providerId="LiveId" clId="{5D54F2F7-37EB-9E44-A1F3-9635274EB662}" dt="2024-11-09T00:24:10.254" v="735" actId="1036"/>
          <ac:spMkLst>
            <pc:docMk/>
            <pc:sldMk cId="1898814079" sldId="256"/>
            <ac:spMk id="51" creationId="{DF5F65B1-7698-09DB-28E4-1D38D6917406}"/>
          </ac:spMkLst>
        </pc:spChg>
        <pc:spChg chg="mod">
          <ac:chgData name="Sebastian Suarez" userId="c52542867e5c9ea9" providerId="LiveId" clId="{5D54F2F7-37EB-9E44-A1F3-9635274EB662}" dt="2024-11-09T00:23:43.918" v="723" actId="1036"/>
          <ac:spMkLst>
            <pc:docMk/>
            <pc:sldMk cId="1898814079" sldId="256"/>
            <ac:spMk id="56" creationId="{F594BA39-7911-C0FC-7E82-328E96AFB434}"/>
          </ac:spMkLst>
        </pc:spChg>
        <pc:spChg chg="mod">
          <ac:chgData name="Sebastian Suarez" userId="c52542867e5c9ea9" providerId="LiveId" clId="{5D54F2F7-37EB-9E44-A1F3-9635274EB662}" dt="2024-11-09T00:23:31.502" v="716" actId="1035"/>
          <ac:spMkLst>
            <pc:docMk/>
            <pc:sldMk cId="1898814079" sldId="256"/>
            <ac:spMk id="58" creationId="{D520F000-6BF8-B742-1C2E-E5D3D0F8E6C1}"/>
          </ac:spMkLst>
        </pc:spChg>
        <pc:spChg chg="mod">
          <ac:chgData name="Sebastian Suarez" userId="c52542867e5c9ea9" providerId="LiveId" clId="{5D54F2F7-37EB-9E44-A1F3-9635274EB662}" dt="2024-11-09T00:23:31.502" v="716" actId="1035"/>
          <ac:spMkLst>
            <pc:docMk/>
            <pc:sldMk cId="1898814079" sldId="256"/>
            <ac:spMk id="60" creationId="{E9F63594-AF2C-40BD-5FD8-9D45ED592125}"/>
          </ac:spMkLst>
        </pc:spChg>
        <pc:spChg chg="mod">
          <ac:chgData name="Sebastian Suarez" userId="c52542867e5c9ea9" providerId="LiveId" clId="{5D54F2F7-37EB-9E44-A1F3-9635274EB662}" dt="2024-11-09T00:23:17.024" v="695" actId="1035"/>
          <ac:spMkLst>
            <pc:docMk/>
            <pc:sldMk cId="1898814079" sldId="256"/>
            <ac:spMk id="64" creationId="{480FD29F-69CC-07F3-F774-75CF4317062C}"/>
          </ac:spMkLst>
        </pc:spChg>
        <pc:spChg chg="mod">
          <ac:chgData name="Sebastian Suarez" userId="c52542867e5c9ea9" providerId="LiveId" clId="{5D54F2F7-37EB-9E44-A1F3-9635274EB662}" dt="2024-11-09T00:23:17.024" v="695" actId="1035"/>
          <ac:spMkLst>
            <pc:docMk/>
            <pc:sldMk cId="1898814079" sldId="256"/>
            <ac:spMk id="65" creationId="{EE51B18A-DC9E-BE99-8803-2FAF50B180A8}"/>
          </ac:spMkLst>
        </pc:spChg>
        <pc:spChg chg="mod">
          <ac:chgData name="Sebastian Suarez" userId="c52542867e5c9ea9" providerId="LiveId" clId="{5D54F2F7-37EB-9E44-A1F3-9635274EB662}" dt="2024-11-09T00:23:17.024" v="695" actId="1035"/>
          <ac:spMkLst>
            <pc:docMk/>
            <pc:sldMk cId="1898814079" sldId="256"/>
            <ac:spMk id="66" creationId="{606F4DC1-954E-9B77-02E5-3252414D1033}"/>
          </ac:spMkLst>
        </pc:spChg>
        <pc:spChg chg="mod">
          <ac:chgData name="Sebastian Suarez" userId="c52542867e5c9ea9" providerId="LiveId" clId="{5D54F2F7-37EB-9E44-A1F3-9635274EB662}" dt="2024-11-09T00:24:27.981" v="764" actId="1035"/>
          <ac:spMkLst>
            <pc:docMk/>
            <pc:sldMk cId="1898814079" sldId="256"/>
            <ac:spMk id="92" creationId="{7BDD7C7C-E341-13B4-A193-1032D2EC8C26}"/>
          </ac:spMkLst>
        </pc:spChg>
        <pc:spChg chg="mod">
          <ac:chgData name="Sebastian Suarez" userId="c52542867e5c9ea9" providerId="LiveId" clId="{5D54F2F7-37EB-9E44-A1F3-9635274EB662}" dt="2024-11-09T00:23:17.024" v="695" actId="1035"/>
          <ac:spMkLst>
            <pc:docMk/>
            <pc:sldMk cId="1898814079" sldId="256"/>
            <ac:spMk id="106" creationId="{DA7A88C2-A0CA-30AF-FAF9-D07D59503A1B}"/>
          </ac:spMkLst>
        </pc:spChg>
        <pc:graphicFrameChg chg="mod modGraphic">
          <ac:chgData name="Sebastian Suarez" userId="c52542867e5c9ea9" providerId="LiveId" clId="{5D54F2F7-37EB-9E44-A1F3-9635274EB662}" dt="2024-11-09T00:23:43.918" v="723" actId="1036"/>
          <ac:graphicFrameMkLst>
            <pc:docMk/>
            <pc:sldMk cId="1898814079" sldId="256"/>
            <ac:graphicFrameMk id="57" creationId="{93271CC8-450C-C28F-69F4-5B5F49087D59}"/>
          </ac:graphicFrameMkLst>
        </pc:graphicFrameChg>
        <pc:cxnChg chg="mod">
          <ac:chgData name="Sebastian Suarez" userId="c52542867e5c9ea9" providerId="LiveId" clId="{5D54F2F7-37EB-9E44-A1F3-9635274EB662}" dt="2024-11-09T00:23:51.619" v="729" actId="1036"/>
          <ac:cxnSpMkLst>
            <pc:docMk/>
            <pc:sldMk cId="1898814079" sldId="256"/>
            <ac:cxnSpMk id="54" creationId="{34DD2EF0-9F2C-F1BA-DA1D-C029C7CFBD98}"/>
          </ac:cxnSpMkLst>
        </pc:cxnChg>
        <pc:cxnChg chg="mod">
          <ac:chgData name="Sebastian Suarez" userId="c52542867e5c9ea9" providerId="LiveId" clId="{5D54F2F7-37EB-9E44-A1F3-9635274EB662}" dt="2024-11-09T00:23:24.336" v="704" actId="1036"/>
          <ac:cxnSpMkLst>
            <pc:docMk/>
            <pc:sldMk cId="1898814079" sldId="256"/>
            <ac:cxnSpMk id="63" creationId="{6778C3FC-9405-3AF7-AC2E-620C77303DBA}"/>
          </ac:cxnSpMkLst>
        </pc:cxnChg>
        <pc:cxnChg chg="mod">
          <ac:chgData name="Sebastian Suarez" userId="c52542867e5c9ea9" providerId="LiveId" clId="{5D54F2F7-37EB-9E44-A1F3-9635274EB662}" dt="2024-11-09T00:24:21.746" v="752" actId="1036"/>
          <ac:cxnSpMkLst>
            <pc:docMk/>
            <pc:sldMk cId="1898814079" sldId="256"/>
            <ac:cxnSpMk id="86" creationId="{8512916F-C986-CC42-A55A-011D7A1106FE}"/>
          </ac:cxnSpMkLst>
        </pc:cxnChg>
      </pc:sldChg>
    </pc:docChg>
  </pc:docChgLst>
  <pc:docChgLst>
    <pc:chgData name="Sebastian Suarez" userId="c52542867e5c9ea9" providerId="LiveId" clId="{D4A72FF3-037D-1D4B-90D0-E35C643A4C37}"/>
    <pc:docChg chg="undo custSel modSld">
      <pc:chgData name="Sebastian Suarez" userId="c52542867e5c9ea9" providerId="LiveId" clId="{D4A72FF3-037D-1D4B-90D0-E35C643A4C37}" dt="2023-02-03T16:54:27.628" v="232" actId="207"/>
      <pc:docMkLst>
        <pc:docMk/>
      </pc:docMkLst>
      <pc:sldChg chg="modSp mod">
        <pc:chgData name="Sebastian Suarez" userId="c52542867e5c9ea9" providerId="LiveId" clId="{D4A72FF3-037D-1D4B-90D0-E35C643A4C37}" dt="2023-02-03T16:54:27.628" v="232" actId="207"/>
        <pc:sldMkLst>
          <pc:docMk/>
          <pc:sldMk cId="1898814079" sldId="256"/>
        </pc:sldMkLst>
      </pc:sldChg>
    </pc:docChg>
  </pc:docChgLst>
  <pc:docChgLst>
    <pc:chgData name="Sebastian Suarez" userId="c52542867e5c9ea9" providerId="LiveId" clId="{D1D509DF-FD1A-D84D-B834-350F06387A57}"/>
    <pc:docChg chg="undo custSel modSld">
      <pc:chgData name="Sebastian Suarez" userId="c52542867e5c9ea9" providerId="LiveId" clId="{D1D509DF-FD1A-D84D-B834-350F06387A57}" dt="2024-08-28T19:25:29.605" v="562" actId="20577"/>
      <pc:docMkLst>
        <pc:docMk/>
      </pc:docMkLst>
      <pc:sldChg chg="modSp mod modNotesTx">
        <pc:chgData name="Sebastian Suarez" userId="c52542867e5c9ea9" providerId="LiveId" clId="{D1D509DF-FD1A-D84D-B834-350F06387A57}" dt="2024-08-28T19:25:29.605" v="562" actId="20577"/>
        <pc:sldMkLst>
          <pc:docMk/>
          <pc:sldMk cId="1898814079" sldId="256"/>
        </pc:sldMkLst>
      </pc:sldChg>
    </pc:docChg>
  </pc:docChgLst>
  <pc:docChgLst>
    <pc:chgData name="Sebastian Suarez" userId="c52542867e5c9ea9" providerId="LiveId" clId="{E3E2ACBE-E189-D642-B51E-5E04D3C13E4E}"/>
    <pc:docChg chg="undo custSel modSld">
      <pc:chgData name="Sebastian Suarez" userId="c52542867e5c9ea9" providerId="LiveId" clId="{E3E2ACBE-E189-D642-B51E-5E04D3C13E4E}" dt="2025-01-07T22:01:15.487" v="38" actId="12"/>
      <pc:docMkLst>
        <pc:docMk/>
      </pc:docMkLst>
      <pc:sldChg chg="modSp mod modNotesTx">
        <pc:chgData name="Sebastian Suarez" userId="c52542867e5c9ea9" providerId="LiveId" clId="{E3E2ACBE-E189-D642-B51E-5E04D3C13E4E}" dt="2025-01-07T22:01:15.487" v="38" actId="12"/>
        <pc:sldMkLst>
          <pc:docMk/>
          <pc:sldMk cId="1898814079" sldId="256"/>
        </pc:sldMkLst>
        <pc:spChg chg="mod">
          <ac:chgData name="Sebastian Suarez" userId="c52542867e5c9ea9" providerId="LiveId" clId="{E3E2ACBE-E189-D642-B51E-5E04D3C13E4E}" dt="2025-01-07T21:51:17.710" v="33" actId="6549"/>
          <ac:spMkLst>
            <pc:docMk/>
            <pc:sldMk cId="1898814079" sldId="256"/>
            <ac:spMk id="38" creationId="{ECEACCFE-F99E-8280-D1F6-9349A1B5303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B4B58F-4381-344E-860A-8005DC17B4D1}" type="datetimeFigureOut">
              <a:rPr lang="en-US" smtClean="0"/>
              <a:t>1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E12823-9008-8143-85B9-8ECBF9E009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2318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45720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ote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: This is a modified version made to enhance accuracy from the original tool, given updates in practice. The original tool used in the curriculum only had minor differences. ALP, alkaline phosphatase; BMP, basic metabolic panel; CVD, cardiovascular disease; F/U, follow-up; H/H, hematocrit and hemoglobin; HDL, high-density lipoprotein; HTN, hypertension;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x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history; IM, intramuscular; K, potassium; LFTs, liver function tests; LDL, low-density lipoprotein; PO, by mouth; pt, patient; SQ, subcutaneous; SUD, substance use disorder; T2DM, type 2 diabetes mellitus; TD, transdermal; TG, triglycerides; VTE, venous thromboembolism; w/, with</a:t>
            </a: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457200" indent="0">
              <a:buFont typeface="+mj-lt"/>
              <a:buNone/>
            </a:pP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E12823-9008-8143-85B9-8ECBF9E009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3221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CE4D5-C095-A094-2B6E-CA0244816D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68D362-8FD9-25C2-086D-6386E0A0C6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C955C7-5C99-3A04-0FB3-83E41DFFD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9511B4-6764-D645-21B9-322B9E802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6A62F-C669-D5FF-E679-CB658A279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356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BFADD-830C-6E12-5CEF-2A2CB322B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81884C-D6B4-715A-42FA-2C023DFCDD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9D4D81-3136-CC5C-38F3-B445513A1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8268A8-5005-36A7-22FB-CBF0AB9DD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9C32E5-55F9-7612-6D0D-B23189829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151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BF706E-55F6-260E-F0BC-B05C94F036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EA04C4-3958-3503-600A-2C01859801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1CBD2F-C008-F94F-FD92-CEDD6C25E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4AFFA4-19A2-F89C-D917-E35A37669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61428-5532-6F37-CE78-BD9AD971D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921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E7A58-98BC-BCBD-3272-63F09BAC1A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2398D2-0AE9-4AF0-B6F1-BF2B7D42B7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7DA574-D5D1-0998-72C1-23F92FCC0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D11C13-3D1A-FBA5-DDE3-171CABF35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D83624-5BE9-89C1-8630-67243FD4D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335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C11089-1602-4168-2F23-9BE45054AE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1E1514-2BDE-E943-99E7-9B8B6380C6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28E57E-B5F2-6973-0FFC-69C480DCD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C9DC80-7D21-56AE-3109-FC16242FF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ABB62F-A33D-EC84-89F2-538CB7753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372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A8BC0-A840-5484-9CD2-EA9AD3540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D23871-B019-35C3-2A15-C748C71CF1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B5085B-667A-984E-7E75-9341DAEBF8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E4E95B-923C-429B-9EEB-E4404E72A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335CDC-63EC-7604-1CE8-EA273A011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7D87F6-0BDC-C6FE-DB72-5D6C4DB10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035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07CAC-F70B-AE91-7E0E-826D85687E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F48E0B-7BBE-1993-4EAB-9EEA8A7347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6E9A83-7C02-7B50-61F3-044B668BC3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EA9120-BCDD-6369-57FE-4CFB71D0B1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58333BA-73F9-E5AD-9660-2B86EF5D4A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33D72D-C11C-091F-7859-0C5675C54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884749-9E79-4E9F-082A-0DA7BB93C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9D28F2-376B-C49A-9B9F-8B8151818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127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3ADB9-F111-F9BF-E197-889974E5F8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33A8F5-158C-C90F-90D7-2D93D9088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08CB37-BE5C-5BAA-F190-C0879193C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259FC9-3BC3-A2FD-66FC-DE2615C26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14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413360-9BB4-A14B-2942-A059C784E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726609-F891-9978-DE46-5B1EECA75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038FD3-2B67-792F-F112-21EB85479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74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73247C-DE9A-EF1C-6FA2-B847A7FC4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E61451-7978-948E-2C74-1A50D79EBD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B8EE0A-A0EE-1777-15BF-4FCFDC216C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D33F81-88DA-99BB-745E-07EF15F89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075C6-0A7A-664D-9329-60FF8A8CD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522F39-F11A-5FD3-C7D1-725EE066D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70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D4D53-F3D3-C6FF-959C-E89A0108AA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AA37E9-B7D5-A864-07AA-8F0C56D70B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266B84-7DA3-1486-CCB0-40FEA043F8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19ED9E-386A-079E-6437-A5963CD20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C0109D-D39A-E56D-C5D3-358A96816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C9ABA3-81DA-932D-6DB8-B01FB2105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375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F9C33B-9DD8-EA06-F040-7220419B50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07234A-AE37-DCA8-2491-4ED6E0BB7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6857E-DE38-E4B7-23C6-2962FD2879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4A8B1-12DC-864A-9622-47479E21C9AA}" type="datetimeFigureOut">
              <a:rPr lang="en-US" smtClean="0"/>
              <a:t>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F3B8F5-A5CF-9D31-9412-DF9B1667E0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A03A0E-908D-BC2D-BE38-3641DF30AD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9FD97-EFD7-B342-B63B-8BBBF741E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486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Rectangle 82">
            <a:extLst>
              <a:ext uri="{FF2B5EF4-FFF2-40B4-BE49-F238E27FC236}">
                <a16:creationId xmlns:a16="http://schemas.microsoft.com/office/drawing/2014/main" id="{170891F5-A355-FA79-F34D-78644A52646A}"/>
              </a:ext>
            </a:extLst>
          </p:cNvPr>
          <p:cNvSpPr/>
          <p:nvPr/>
        </p:nvSpPr>
        <p:spPr>
          <a:xfrm>
            <a:off x="0" y="-1"/>
            <a:ext cx="12191385" cy="559497"/>
          </a:xfrm>
          <a:prstGeom prst="rect">
            <a:avLst/>
          </a:prstGeom>
          <a:gradFill flip="none" rotWithShape="1">
            <a:gsLst>
              <a:gs pos="0">
                <a:srgbClr val="66E2FA"/>
              </a:gs>
              <a:gs pos="85000">
                <a:schemeClr val="bg1"/>
              </a:gs>
              <a:gs pos="15000">
                <a:schemeClr val="bg1"/>
              </a:gs>
              <a:gs pos="100000">
                <a:srgbClr val="F7BDCB"/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23BD5BE-6CE8-65FD-470A-FAC3026DB7EE}"/>
              </a:ext>
            </a:extLst>
          </p:cNvPr>
          <p:cNvSpPr txBox="1"/>
          <p:nvPr/>
        </p:nvSpPr>
        <p:spPr>
          <a:xfrm>
            <a:off x="400050" y="0"/>
            <a:ext cx="117919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Helvetica" pitchFamily="2" charset="0"/>
                <a:cs typeface="Arial" panose="020B0604020202020204" pitchFamily="34" charset="0"/>
              </a:rPr>
              <a:t>Gender affirming hormone therapy (GAHT)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AEFE036-8A50-EF8D-050C-C73A89E69E57}"/>
              </a:ext>
            </a:extLst>
          </p:cNvPr>
          <p:cNvCxnSpPr>
            <a:cxnSpLocks/>
          </p:cNvCxnSpPr>
          <p:nvPr/>
        </p:nvCxnSpPr>
        <p:spPr>
          <a:xfrm>
            <a:off x="-2" y="559496"/>
            <a:ext cx="1219200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aphicFrame>
        <p:nvGraphicFramePr>
          <p:cNvPr id="31" name="Table 8">
            <a:extLst>
              <a:ext uri="{FF2B5EF4-FFF2-40B4-BE49-F238E27FC236}">
                <a16:creationId xmlns:a16="http://schemas.microsoft.com/office/drawing/2014/main" id="{760FA9FF-1A0B-3986-98FA-C3CE3DB535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7985953"/>
              </p:ext>
            </p:extLst>
          </p:nvPr>
        </p:nvGraphicFramePr>
        <p:xfrm>
          <a:off x="175273" y="1899393"/>
          <a:ext cx="3249913" cy="2444693"/>
        </p:xfrm>
        <a:graphic>
          <a:graphicData uri="http://schemas.openxmlformats.org/drawingml/2006/table">
            <a:tbl>
              <a:tblPr firstRow="1" bandRow="1">
                <a:tableStyleId>{7DF18680-E054-41AD-8BC1-D1AEF772440D}</a:tableStyleId>
              </a:tblPr>
              <a:tblGrid>
                <a:gridCol w="1639417">
                  <a:extLst>
                    <a:ext uri="{9D8B030D-6E8A-4147-A177-3AD203B41FA5}">
                      <a16:colId xmlns:a16="http://schemas.microsoft.com/office/drawing/2014/main" val="2923879866"/>
                    </a:ext>
                  </a:extLst>
                </a:gridCol>
                <a:gridCol w="777360">
                  <a:extLst>
                    <a:ext uri="{9D8B030D-6E8A-4147-A177-3AD203B41FA5}">
                      <a16:colId xmlns:a16="http://schemas.microsoft.com/office/drawing/2014/main" val="1046319722"/>
                    </a:ext>
                  </a:extLst>
                </a:gridCol>
                <a:gridCol w="833136">
                  <a:extLst>
                    <a:ext uri="{9D8B030D-6E8A-4147-A177-3AD203B41FA5}">
                      <a16:colId xmlns:a16="http://schemas.microsoft.com/office/drawing/2014/main" val="3271404803"/>
                    </a:ext>
                  </a:extLst>
                </a:gridCol>
              </a:tblGrid>
              <a:tr h="22414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Estradiol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Onset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ximum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613562803"/>
                  </a:ext>
                </a:extLst>
              </a:tr>
              <a:tr h="224140">
                <a:tc>
                  <a:txBody>
                    <a:bodyPr/>
                    <a:lstStyle/>
                    <a:p>
                      <a:r>
                        <a:rPr lang="en-US" sz="1000" dirty="0"/>
                        <a:t>⬇ sexual desire </a:t>
                      </a:r>
                    </a:p>
                  </a:txBody>
                  <a:tcPr marL="54578" marR="54578" marT="27290" marB="27290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-3 month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Unknown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3441002349"/>
                  </a:ext>
                </a:extLst>
              </a:tr>
              <a:tr h="210027">
                <a:tc>
                  <a:txBody>
                    <a:bodyPr/>
                    <a:lstStyle/>
                    <a:p>
                      <a:r>
                        <a:rPr lang="en-US" sz="1000" dirty="0"/>
                        <a:t>⬇ spontaneous erections</a:t>
                      </a:r>
                    </a:p>
                  </a:txBody>
                  <a:tcPr marL="54578" marR="54578" marT="27290" marB="2729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3-6 months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3815855968"/>
                  </a:ext>
                </a:extLst>
              </a:tr>
              <a:tr h="2241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⬇ in muscle mass</a:t>
                      </a:r>
                    </a:p>
                  </a:txBody>
                  <a:tcPr marL="54578" marR="54578" marT="27290" marB="27290"/>
                </a:tc>
                <a:tc rowSpan="5"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3-6 month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1-2 years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3766451541"/>
                  </a:ext>
                </a:extLst>
              </a:tr>
              <a:tr h="2241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Redistribution of body fat</a:t>
                      </a:r>
                    </a:p>
                  </a:txBody>
                  <a:tcPr marL="54578" marR="54578" marT="27290" marB="2729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2-5 years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1822669618"/>
                  </a:ext>
                </a:extLst>
              </a:tr>
              <a:tr h="2241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1" dirty="0"/>
                        <a:t>Breast growth</a:t>
                      </a:r>
                    </a:p>
                  </a:txBody>
                  <a:tcPr marL="54578" marR="54578" marT="27290" marB="2729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2-5 years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3931896488"/>
                  </a:ext>
                </a:extLst>
              </a:tr>
              <a:tr h="230709">
                <a:tc>
                  <a:txBody>
                    <a:bodyPr/>
                    <a:lstStyle/>
                    <a:p>
                      <a:r>
                        <a:rPr lang="en-US" sz="1000" dirty="0"/>
                        <a:t>Skin softening and ⬇ oiliness</a:t>
                      </a:r>
                    </a:p>
                  </a:txBody>
                  <a:tcPr marL="54578" marR="54578" marT="27290" marB="2729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Unknown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3137535494"/>
                  </a:ext>
                </a:extLst>
              </a:tr>
              <a:tr h="232858">
                <a:tc>
                  <a:txBody>
                    <a:bodyPr/>
                    <a:lstStyle/>
                    <a:p>
                      <a:r>
                        <a:rPr lang="en-US" sz="1000" dirty="0"/>
                        <a:t>⬇ testicular volume</a:t>
                      </a:r>
                    </a:p>
                  </a:txBody>
                  <a:tcPr marL="54578" marR="54578" marT="27290" marB="2729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Variable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956131877"/>
                  </a:ext>
                </a:extLst>
              </a:tr>
              <a:tr h="21002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⬇ terminal hair growth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6-12 months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&gt;3 years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3891571505"/>
                  </a:ext>
                </a:extLst>
              </a:tr>
              <a:tr h="22414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⬆️ scalp hair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Variable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Variable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1681619190"/>
                  </a:ext>
                </a:extLst>
              </a:tr>
              <a:tr h="216232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⬇ sperm production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Unknown</a:t>
                      </a:r>
                    </a:p>
                  </a:txBody>
                  <a:tcPr marL="54578" marR="54578" marT="27290" marB="27290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2 years</a:t>
                      </a:r>
                    </a:p>
                  </a:txBody>
                  <a:tcPr marL="54578" marR="54578" marT="27290" marB="27290"/>
                </a:tc>
                <a:extLst>
                  <a:ext uri="{0D108BD9-81ED-4DB2-BD59-A6C34878D82A}">
                    <a16:rowId xmlns:a16="http://schemas.microsoft.com/office/drawing/2014/main" val="1544128521"/>
                  </a:ext>
                </a:extLst>
              </a:tr>
            </a:tbl>
          </a:graphicData>
        </a:graphic>
      </p:graphicFrame>
      <p:graphicFrame>
        <p:nvGraphicFramePr>
          <p:cNvPr id="32" name="Table 4">
            <a:extLst>
              <a:ext uri="{FF2B5EF4-FFF2-40B4-BE49-F238E27FC236}">
                <a16:creationId xmlns:a16="http://schemas.microsoft.com/office/drawing/2014/main" id="{284A8CE2-7994-FA7C-81AB-C373640ED4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5312293"/>
              </p:ext>
            </p:extLst>
          </p:nvPr>
        </p:nvGraphicFramePr>
        <p:xfrm>
          <a:off x="172782" y="4427576"/>
          <a:ext cx="3251732" cy="2113905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1585845">
                  <a:extLst>
                    <a:ext uri="{9D8B030D-6E8A-4147-A177-3AD203B41FA5}">
                      <a16:colId xmlns:a16="http://schemas.microsoft.com/office/drawing/2014/main" val="2487154064"/>
                    </a:ext>
                  </a:extLst>
                </a:gridCol>
                <a:gridCol w="812815">
                  <a:extLst>
                    <a:ext uri="{9D8B030D-6E8A-4147-A177-3AD203B41FA5}">
                      <a16:colId xmlns:a16="http://schemas.microsoft.com/office/drawing/2014/main" val="2352757270"/>
                    </a:ext>
                  </a:extLst>
                </a:gridCol>
                <a:gridCol w="853072">
                  <a:extLst>
                    <a:ext uri="{9D8B030D-6E8A-4147-A177-3AD203B41FA5}">
                      <a16:colId xmlns:a16="http://schemas.microsoft.com/office/drawing/2014/main" val="290287111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estosterone</a:t>
                      </a:r>
                    </a:p>
                  </a:txBody>
                  <a:tcPr marL="42641" marR="42641" marT="21321" marB="21321"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Onset</a:t>
                      </a:r>
                    </a:p>
                  </a:txBody>
                  <a:tcPr marL="42641" marR="42641" marT="21321" marB="21321"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Maximum</a:t>
                      </a:r>
                    </a:p>
                  </a:txBody>
                  <a:tcPr marL="42641" marR="42641" marT="21321" marB="21321"/>
                </a:tc>
                <a:extLst>
                  <a:ext uri="{0D108BD9-81ED-4DB2-BD59-A6C34878D82A}">
                    <a16:rowId xmlns:a16="http://schemas.microsoft.com/office/drawing/2014/main" val="2124676380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r>
                        <a:rPr lang="en-US" sz="1000" dirty="0"/>
                        <a:t>Cessation of menses</a:t>
                      </a:r>
                    </a:p>
                  </a:txBody>
                  <a:tcPr marL="42641" marR="42641" marT="21321" marB="21321"/>
                </a:tc>
                <a:tc rowSpan="6"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u="none" strike="noStrike" noProof="0" dirty="0"/>
                        <a:t>1-6 months</a:t>
                      </a:r>
                      <a:endParaRPr lang="en-US" sz="1000" dirty="0"/>
                    </a:p>
                  </a:txBody>
                  <a:tcPr marL="0" marR="0" marT="0" marB="0" anchor="ctr"/>
                </a:tc>
                <a:tc rowSpan="5"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u="none" strike="noStrike" noProof="0" dirty="0"/>
                        <a:t>1-2 years</a:t>
                      </a:r>
                      <a:endParaRPr lang="en-US" sz="1000" dirty="0"/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623355668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1" dirty="0"/>
                        <a:t>Clitoral enlargement</a:t>
                      </a:r>
                    </a:p>
                  </a:txBody>
                  <a:tcPr marL="42641" marR="42641" marT="21321" marB="21321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extLst>
                  <a:ext uri="{0D108BD9-81ED-4DB2-BD59-A6C34878D82A}">
                    <a16:rowId xmlns:a16="http://schemas.microsoft.com/office/drawing/2014/main" val="1850939448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Vaginal atrophy</a:t>
                      </a:r>
                    </a:p>
                  </a:txBody>
                  <a:tcPr marL="42641" marR="42641" marT="21321" marB="21321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extLst>
                  <a:ext uri="{0D108BD9-81ED-4DB2-BD59-A6C34878D82A}">
                    <a16:rowId xmlns:a16="http://schemas.microsoft.com/office/drawing/2014/main" val="2726786675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1" dirty="0"/>
                        <a:t>Deepening of voice</a:t>
                      </a:r>
                    </a:p>
                  </a:txBody>
                  <a:tcPr marL="42641" marR="42641" marT="21321" marB="21321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extLst>
                  <a:ext uri="{0D108BD9-81ED-4DB2-BD59-A6C34878D82A}">
                    <a16:rowId xmlns:a16="http://schemas.microsoft.com/office/drawing/2014/main" val="3355290079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Skin oiliness/acne</a:t>
                      </a:r>
                    </a:p>
                  </a:txBody>
                  <a:tcPr marL="42641" marR="42641" marT="21321" marB="21321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extLst>
                  <a:ext uri="{0D108BD9-81ED-4DB2-BD59-A6C34878D82A}">
                    <a16:rowId xmlns:a16="http://schemas.microsoft.com/office/drawing/2014/main" val="143938217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Fat redistribution</a:t>
                      </a:r>
                      <a:endParaRPr lang="en-US" sz="1000"/>
                    </a:p>
                  </a:txBody>
                  <a:tcPr marL="42641" marR="42641" marT="21321" marB="21321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u="none" strike="noStrike" noProof="0" dirty="0"/>
                        <a:t>2-5 years</a:t>
                      </a:r>
                      <a:endParaRPr lang="en-US" sz="1000" dirty="0"/>
                    </a:p>
                  </a:txBody>
                  <a:tcPr marL="42641" marR="42641" marT="21321" marB="21321"/>
                </a:tc>
                <a:extLst>
                  <a:ext uri="{0D108BD9-81ED-4DB2-BD59-A6C34878D82A}">
                    <a16:rowId xmlns:a16="http://schemas.microsoft.com/office/drawing/2014/main" val="1819439052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⬆️ muscle mass</a:t>
                      </a:r>
                    </a:p>
                  </a:txBody>
                  <a:tcPr marL="42641" marR="42641" marT="21321" marB="21321"/>
                </a:tc>
                <a:tc rowSpan="3"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6-12 month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2-5 years</a:t>
                      </a:r>
                    </a:p>
                  </a:txBody>
                  <a:tcPr marL="42641" marR="42641" marT="21321" marB="21321"/>
                </a:tc>
                <a:extLst>
                  <a:ext uri="{0D108BD9-81ED-4DB2-BD59-A6C34878D82A}">
                    <a16:rowId xmlns:a16="http://schemas.microsoft.com/office/drawing/2014/main" val="662491616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1" dirty="0"/>
                        <a:t>Scalp hair loss</a:t>
                      </a:r>
                    </a:p>
                  </a:txBody>
                  <a:tcPr marL="42641" marR="42641" marT="21321" marB="21321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 rowSpan="2"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/>
                        <a:t>&gt;5 years</a:t>
                      </a:r>
                      <a:endParaRPr lang="en-US" sz="1000"/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252910619"/>
                  </a:ext>
                </a:extLst>
              </a:tr>
              <a:tr h="21320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1" dirty="0"/>
                        <a:t>Facial/body hair growth</a:t>
                      </a:r>
                    </a:p>
                  </a:txBody>
                  <a:tcPr marL="42641" marR="42641" marT="21321" marB="21321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horzOverflow="overflow"/>
                </a:tc>
                <a:extLst>
                  <a:ext uri="{0D108BD9-81ED-4DB2-BD59-A6C34878D82A}">
                    <a16:rowId xmlns:a16="http://schemas.microsoft.com/office/drawing/2014/main" val="540296968"/>
                  </a:ext>
                </a:extLst>
              </a:tr>
            </a:tbl>
          </a:graphicData>
        </a:graphic>
      </p:graphicFrame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BC5DC0A-6EBE-F5F2-F30A-03BC69004FBE}"/>
              </a:ext>
            </a:extLst>
          </p:cNvPr>
          <p:cNvCxnSpPr>
            <a:cxnSpLocks/>
          </p:cNvCxnSpPr>
          <p:nvPr/>
        </p:nvCxnSpPr>
        <p:spPr>
          <a:xfrm>
            <a:off x="3582230" y="570603"/>
            <a:ext cx="0" cy="628739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3B109392-2303-AC58-E12F-267524A1DBE0}"/>
              </a:ext>
            </a:extLst>
          </p:cNvPr>
          <p:cNvCxnSpPr>
            <a:cxnSpLocks/>
          </p:cNvCxnSpPr>
          <p:nvPr/>
        </p:nvCxnSpPr>
        <p:spPr>
          <a:xfrm>
            <a:off x="7579139" y="562036"/>
            <a:ext cx="18218" cy="629596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EF62438-B08D-CFFB-984B-9A7DCE164801}"/>
              </a:ext>
            </a:extLst>
          </p:cNvPr>
          <p:cNvSpPr txBox="1"/>
          <p:nvPr/>
        </p:nvSpPr>
        <p:spPr>
          <a:xfrm>
            <a:off x="-2" y="1659090"/>
            <a:ext cx="358224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2a. Set expectations about physical changes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19E1F63B-C568-1445-F14C-65FCB330217C}"/>
              </a:ext>
            </a:extLst>
          </p:cNvPr>
          <p:cNvCxnSpPr>
            <a:cxnSpLocks/>
          </p:cNvCxnSpPr>
          <p:nvPr/>
        </p:nvCxnSpPr>
        <p:spPr>
          <a:xfrm>
            <a:off x="7592346" y="4944962"/>
            <a:ext cx="461224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ECEACCFE-F99E-8280-D1F6-9349A1B5303E}"/>
              </a:ext>
            </a:extLst>
          </p:cNvPr>
          <p:cNvSpPr txBox="1"/>
          <p:nvPr/>
        </p:nvSpPr>
        <p:spPr>
          <a:xfrm>
            <a:off x="7599869" y="2752232"/>
            <a:ext cx="4591516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cs typeface="Calibri"/>
              </a:rPr>
              <a:t>*Can start at lower dose for individualized GAHT. Can also titrate slowly</a:t>
            </a:r>
          </a:p>
          <a:p>
            <a:r>
              <a:rPr lang="en-US" sz="1000" dirty="0">
                <a:cs typeface="Calibri"/>
              </a:rPr>
              <a:t>**TD: Transdermal estradiol can be used if increased VTE risk such as: &gt;45 yrs or hx unprovoked VTE, or development of VTE while on estrogen, or if aligned w/ pt goals</a:t>
            </a:r>
          </a:p>
          <a:p>
            <a:r>
              <a:rPr lang="en-US" sz="1000" dirty="0">
                <a:ea typeface="+mn-lt"/>
                <a:cs typeface="Calibri"/>
              </a:rPr>
              <a:t>- Injectable estrogen therapy is evolving and not included here. See other references</a:t>
            </a:r>
            <a:endParaRPr lang="en-US" sz="1000" dirty="0">
              <a:cs typeface="Calibri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E58AED9-BD85-B91E-81F8-3CD80742E897}"/>
              </a:ext>
            </a:extLst>
          </p:cNvPr>
          <p:cNvSpPr txBox="1"/>
          <p:nvPr/>
        </p:nvSpPr>
        <p:spPr>
          <a:xfrm>
            <a:off x="3595783" y="2046629"/>
            <a:ext cx="399605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Estrogen 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  <a:sym typeface="Wingdings" pitchFamily="2" charset="2"/>
              </a:rPr>
              <a:t>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000" b="1" dirty="0">
                <a:latin typeface="Calibri" panose="020F0502020204030204" pitchFamily="34" charset="0"/>
                <a:cs typeface="Calibri" panose="020F0502020204030204" pitchFamily="34" charset="0"/>
              </a:rPr>
              <a:t>irreversible in some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;</a:t>
            </a:r>
            <a:r>
              <a:rPr lang="en-US" sz="10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Testosterone 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  <a:sym typeface="Wingdings" pitchFamily="2" charset="2"/>
              </a:rPr>
              <a:t>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000" b="1" dirty="0">
                <a:latin typeface="Calibri" panose="020F0502020204030204" pitchFamily="34" charset="0"/>
                <a:cs typeface="Calibri" panose="020F0502020204030204" pitchFamily="34" charset="0"/>
              </a:rPr>
              <a:t>mostly reversibl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ea typeface="+mn-lt"/>
                <a:cs typeface="Calibri" panose="020F0502020204030204" pitchFamily="34" charset="0"/>
              </a:rPr>
              <a:t>Fertility </a:t>
            </a:r>
            <a:r>
              <a:rPr lang="en-US" sz="1000" b="1" i="1" dirty="0">
                <a:latin typeface="Calibri" panose="020F0502020204030204" pitchFamily="34" charset="0"/>
                <a:ea typeface="+mn-lt"/>
                <a:cs typeface="Calibri" panose="020F0502020204030204" pitchFamily="34" charset="0"/>
              </a:rPr>
              <a:t>may </a:t>
            </a:r>
            <a:r>
              <a:rPr lang="en-US" sz="1000" dirty="0">
                <a:latin typeface="Calibri" panose="020F0502020204030204" pitchFamily="34" charset="0"/>
                <a:ea typeface="+mn-lt"/>
                <a:cs typeface="Calibri" panose="020F0502020204030204" pitchFamily="34" charset="0"/>
              </a:rPr>
              <a:t>return 3-6 months after stopping GAH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f still at pregnancy risk 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  <a:sym typeface="Wingdings" pitchFamily="2" charset="2"/>
              </a:rPr>
              <a:t> </a:t>
            </a:r>
            <a:r>
              <a:rPr lang="en-US" sz="1000" u="sng" dirty="0">
                <a:latin typeface="Calibri" panose="020F0502020204030204" pitchFamily="34" charset="0"/>
                <a:cs typeface="Calibri" panose="020F0502020204030204" pitchFamily="34" charset="0"/>
                <a:sym typeface="Wingdings" pitchFamily="2" charset="2"/>
              </a:rPr>
              <a:t>all should use contracep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Offer fertility specialist referral to all TGD patients </a:t>
            </a:r>
          </a:p>
        </p:txBody>
      </p:sp>
      <p:graphicFrame>
        <p:nvGraphicFramePr>
          <p:cNvPr id="43" name="Table 2">
            <a:extLst>
              <a:ext uri="{FF2B5EF4-FFF2-40B4-BE49-F238E27FC236}">
                <a16:creationId xmlns:a16="http://schemas.microsoft.com/office/drawing/2014/main" id="{10F4C834-A55A-76FC-0EB0-5BF21BE19B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3981862"/>
              </p:ext>
            </p:extLst>
          </p:nvPr>
        </p:nvGraphicFramePr>
        <p:xfrm>
          <a:off x="7702217" y="815294"/>
          <a:ext cx="4379912" cy="937260"/>
        </p:xfrm>
        <a:graphic>
          <a:graphicData uri="http://schemas.openxmlformats.org/drawingml/2006/table">
            <a:tbl>
              <a:tblPr firstRow="1" bandRow="1">
                <a:tableStyleId>{7DF18680-E054-41AD-8BC1-D1AEF772440D}</a:tableStyleId>
              </a:tblPr>
              <a:tblGrid>
                <a:gridCol w="1054325">
                  <a:extLst>
                    <a:ext uri="{9D8B030D-6E8A-4147-A177-3AD203B41FA5}">
                      <a16:colId xmlns:a16="http://schemas.microsoft.com/office/drawing/2014/main" val="984483636"/>
                    </a:ext>
                  </a:extLst>
                </a:gridCol>
                <a:gridCol w="923246">
                  <a:extLst>
                    <a:ext uri="{9D8B030D-6E8A-4147-A177-3AD203B41FA5}">
                      <a16:colId xmlns:a16="http://schemas.microsoft.com/office/drawing/2014/main" val="2520126261"/>
                    </a:ext>
                  </a:extLst>
                </a:gridCol>
                <a:gridCol w="783771">
                  <a:extLst>
                    <a:ext uri="{9D8B030D-6E8A-4147-A177-3AD203B41FA5}">
                      <a16:colId xmlns:a16="http://schemas.microsoft.com/office/drawing/2014/main" val="1585309641"/>
                    </a:ext>
                  </a:extLst>
                </a:gridCol>
                <a:gridCol w="809897">
                  <a:extLst>
                    <a:ext uri="{9D8B030D-6E8A-4147-A177-3AD203B41FA5}">
                      <a16:colId xmlns:a16="http://schemas.microsoft.com/office/drawing/2014/main" val="2321628597"/>
                    </a:ext>
                  </a:extLst>
                </a:gridCol>
                <a:gridCol w="808673">
                  <a:extLst>
                    <a:ext uri="{9D8B030D-6E8A-4147-A177-3AD203B41FA5}">
                      <a16:colId xmlns:a16="http://schemas.microsoft.com/office/drawing/2014/main" val="2633701361"/>
                    </a:ext>
                  </a:extLst>
                </a:gridCol>
              </a:tblGrid>
              <a:tr h="137650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bg1"/>
                          </a:solidFill>
                        </a:rPr>
                        <a:t>Estrogen-bas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50" dirty="0"/>
                        <a:t>Initial (low)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50" dirty="0"/>
                        <a:t>Initi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50" dirty="0"/>
                        <a:t>Max do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Commen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81972665"/>
                  </a:ext>
                </a:extLst>
              </a:tr>
              <a:tr h="13514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</a:rPr>
                        <a:t>Estradiol (PO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1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2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8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BID if </a:t>
                      </a:r>
                      <a:r>
                        <a:rPr lang="en-US" sz="900" b="0" u="none" strike="noStrike" noProof="0" dirty="0"/>
                        <a:t>≥4mg</a:t>
                      </a:r>
                      <a:endParaRPr lang="en-US" sz="9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5061114"/>
                  </a:ext>
                </a:extLst>
              </a:tr>
              <a:tr h="13514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</a:rPr>
                        <a:t>Estradiol (TD)*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0.025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0.1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0.4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Q3-5 day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1423714"/>
                  </a:ext>
                </a:extLst>
              </a:tr>
              <a:tr h="13514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</a:rPr>
                        <a:t>Spironolact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25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50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400 mg/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0" i="0" u="none" strike="noStrike" noProof="0" dirty="0">
                          <a:latin typeface="Calibri"/>
                        </a:rPr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8763200"/>
                  </a:ext>
                </a:extLst>
              </a:tr>
            </a:tbl>
          </a:graphicData>
        </a:graphic>
      </p:graphicFrame>
      <p:graphicFrame>
        <p:nvGraphicFramePr>
          <p:cNvPr id="44" name="Table 43">
            <a:extLst>
              <a:ext uri="{FF2B5EF4-FFF2-40B4-BE49-F238E27FC236}">
                <a16:creationId xmlns:a16="http://schemas.microsoft.com/office/drawing/2014/main" id="{DC4F47CA-ED9A-EAC8-FBCB-AFA2F6DB62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9423790"/>
              </p:ext>
            </p:extLst>
          </p:nvPr>
        </p:nvGraphicFramePr>
        <p:xfrm>
          <a:off x="7706807" y="1814419"/>
          <a:ext cx="4375323" cy="9829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0631">
                  <a:extLst>
                    <a:ext uri="{9D8B030D-6E8A-4147-A177-3AD203B41FA5}">
                      <a16:colId xmlns:a16="http://schemas.microsoft.com/office/drawing/2014/main" val="903932077"/>
                    </a:ext>
                  </a:extLst>
                </a:gridCol>
                <a:gridCol w="902043">
                  <a:extLst>
                    <a:ext uri="{9D8B030D-6E8A-4147-A177-3AD203B41FA5}">
                      <a16:colId xmlns:a16="http://schemas.microsoft.com/office/drawing/2014/main" val="217897399"/>
                    </a:ext>
                  </a:extLst>
                </a:gridCol>
                <a:gridCol w="518984">
                  <a:extLst>
                    <a:ext uri="{9D8B030D-6E8A-4147-A177-3AD203B41FA5}">
                      <a16:colId xmlns:a16="http://schemas.microsoft.com/office/drawing/2014/main" val="1964233013"/>
                    </a:ext>
                  </a:extLst>
                </a:gridCol>
                <a:gridCol w="976184">
                  <a:extLst>
                    <a:ext uri="{9D8B030D-6E8A-4147-A177-3AD203B41FA5}">
                      <a16:colId xmlns:a16="http://schemas.microsoft.com/office/drawing/2014/main" val="1516970126"/>
                    </a:ext>
                  </a:extLst>
                </a:gridCol>
                <a:gridCol w="837481">
                  <a:extLst>
                    <a:ext uri="{9D8B030D-6E8A-4147-A177-3AD203B41FA5}">
                      <a16:colId xmlns:a16="http://schemas.microsoft.com/office/drawing/2014/main" val="17471959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bg1"/>
                          </a:solidFill>
                        </a:rPr>
                        <a:t>Testoster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Initial (low)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Initi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Max do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Commen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628218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</a:rPr>
                        <a:t>Testost. cypionate &amp; enthanate (IM/</a:t>
                      </a:r>
                      <a:r>
                        <a:rPr lang="en-US" sz="900" b="1" u="sng" dirty="0">
                          <a:solidFill>
                            <a:schemeClr val="tx1"/>
                          </a:solidFill>
                        </a:rPr>
                        <a:t>SQ</a:t>
                      </a:r>
                      <a:r>
                        <a:rPr lang="en-US" sz="900" dirty="0">
                          <a:solidFill>
                            <a:schemeClr val="tx1"/>
                          </a:solidFill>
                        </a:rPr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20 mg/w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50 mg/wk</a:t>
                      </a: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No max as long as levels therapeutic, typically 100 m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Double dose for q2wk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0009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tx1"/>
                          </a:solidFill>
                        </a:rPr>
                        <a:t>Testosterone gel 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25 mg dai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50 mg daily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In shoulders &amp; arms in A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751206"/>
                  </a:ext>
                </a:extLst>
              </a:tr>
            </a:tbl>
          </a:graphicData>
        </a:graphic>
      </p:graphicFrame>
      <p:sp>
        <p:nvSpPr>
          <p:cNvPr id="45" name="TextBox 44">
            <a:extLst>
              <a:ext uri="{FF2B5EF4-FFF2-40B4-BE49-F238E27FC236}">
                <a16:creationId xmlns:a16="http://schemas.microsoft.com/office/drawing/2014/main" id="{4A2BD54B-585E-35C3-5D67-584BCAAA7A57}"/>
              </a:ext>
            </a:extLst>
          </p:cNvPr>
          <p:cNvSpPr txBox="1"/>
          <p:nvPr/>
        </p:nvSpPr>
        <p:spPr>
          <a:xfrm>
            <a:off x="11379958" y="-2"/>
            <a:ext cx="811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2, 10/2024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8B0578A-AF4D-4A25-A0C9-A37E20E61A98}"/>
              </a:ext>
            </a:extLst>
          </p:cNvPr>
          <p:cNvSpPr txBox="1"/>
          <p:nvPr/>
        </p:nvSpPr>
        <p:spPr>
          <a:xfrm>
            <a:off x="-2" y="357396"/>
            <a:ext cx="121920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ferences: WPATH SOC v8 (2022) and UCSF 2016 guidelines (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edition)</a:t>
            </a:r>
          </a:p>
        </p:txBody>
      </p:sp>
      <p:graphicFrame>
        <p:nvGraphicFramePr>
          <p:cNvPr id="48" name="Table 5">
            <a:extLst>
              <a:ext uri="{FF2B5EF4-FFF2-40B4-BE49-F238E27FC236}">
                <a16:creationId xmlns:a16="http://schemas.microsoft.com/office/drawing/2014/main" id="{4787C658-86B4-BD39-21B0-5F096399BF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651744"/>
              </p:ext>
            </p:extLst>
          </p:nvPr>
        </p:nvGraphicFramePr>
        <p:xfrm>
          <a:off x="7768145" y="5202640"/>
          <a:ext cx="4229690" cy="95729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0701">
                  <a:extLst>
                    <a:ext uri="{9D8B030D-6E8A-4147-A177-3AD203B41FA5}">
                      <a16:colId xmlns:a16="http://schemas.microsoft.com/office/drawing/2014/main" val="3386262710"/>
                    </a:ext>
                  </a:extLst>
                </a:gridCol>
                <a:gridCol w="1350354">
                  <a:extLst>
                    <a:ext uri="{9D8B030D-6E8A-4147-A177-3AD203B41FA5}">
                      <a16:colId xmlns:a16="http://schemas.microsoft.com/office/drawing/2014/main" val="1997464903"/>
                    </a:ext>
                  </a:extLst>
                </a:gridCol>
                <a:gridCol w="1888635">
                  <a:extLst>
                    <a:ext uri="{9D8B030D-6E8A-4147-A177-3AD203B41FA5}">
                      <a16:colId xmlns:a16="http://schemas.microsoft.com/office/drawing/2014/main" val="3456693904"/>
                    </a:ext>
                  </a:extLst>
                </a:gridCol>
              </a:tblGrid>
              <a:tr h="263217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Target levels</a:t>
                      </a:r>
                    </a:p>
                  </a:txBody>
                  <a:tcPr marL="107769" marR="107769" marT="53884" marB="53884"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Estrogen-based</a:t>
                      </a:r>
                    </a:p>
                  </a:txBody>
                  <a:tcPr marL="107769" marR="107769" marT="53884" marB="53884">
                    <a:solidFill>
                      <a:schemeClr val="accent5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Transmasculine (TM)</a:t>
                      </a:r>
                    </a:p>
                  </a:txBody>
                  <a:tcPr marL="107769" marR="107769" marT="53884" marB="53884"/>
                </a:tc>
                <a:extLst>
                  <a:ext uri="{0D108BD9-81ED-4DB2-BD59-A6C34878D82A}">
                    <a16:rowId xmlns:a16="http://schemas.microsoft.com/office/drawing/2014/main" val="3601678056"/>
                  </a:ext>
                </a:extLst>
              </a:tr>
              <a:tr h="263217">
                <a:tc>
                  <a:txBody>
                    <a:bodyPr/>
                    <a:lstStyle/>
                    <a:p>
                      <a:r>
                        <a:rPr lang="en-US" sz="1000" b="1" dirty="0"/>
                        <a:t>Estradiol</a:t>
                      </a:r>
                    </a:p>
                  </a:txBody>
                  <a:tcPr marL="107769" marR="107769" marT="53884" marB="53884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100-200 pg/mL</a:t>
                      </a:r>
                    </a:p>
                  </a:txBody>
                  <a:tcPr marL="107769" marR="107769" marT="53884" marB="53884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Cessation of menses</a:t>
                      </a:r>
                    </a:p>
                  </a:txBody>
                  <a:tcPr marL="107769" marR="107769" marT="53884" marB="53884" anchor="ctr"/>
                </a:tc>
                <a:extLst>
                  <a:ext uri="{0D108BD9-81ED-4DB2-BD59-A6C34878D82A}">
                    <a16:rowId xmlns:a16="http://schemas.microsoft.com/office/drawing/2014/main" val="3293263683"/>
                  </a:ext>
                </a:extLst>
              </a:tr>
              <a:tr h="418665">
                <a:tc>
                  <a:txBody>
                    <a:bodyPr/>
                    <a:lstStyle/>
                    <a:p>
                      <a:r>
                        <a:rPr lang="en-US" sz="1000" b="1" dirty="0"/>
                        <a:t>Total Testosterone</a:t>
                      </a:r>
                    </a:p>
                  </a:txBody>
                  <a:tcPr marL="107769" marR="107769" marT="53884" marB="53884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&lt;50 ng/dL</a:t>
                      </a:r>
                    </a:p>
                  </a:txBody>
                  <a:tcPr marL="107769" marR="107769" marT="53884" marB="53884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400-700 ng/dL</a:t>
                      </a:r>
                    </a:p>
                    <a:p>
                      <a:pPr lvl="0" algn="ctr">
                        <a:buNone/>
                      </a:pPr>
                      <a:r>
                        <a:rPr lang="en-US" sz="1000" dirty="0"/>
                        <a:t>(midway between injections)</a:t>
                      </a:r>
                    </a:p>
                  </a:txBody>
                  <a:tcPr marL="107769" marR="107769" marT="53884" marB="53884" anchor="ctr">
                    <a:solidFill>
                      <a:srgbClr val="DDD0D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0720835"/>
                  </a:ext>
                </a:extLst>
              </a:tr>
            </a:tbl>
          </a:graphicData>
        </a:graphic>
      </p:graphicFrame>
      <p:sp>
        <p:nvSpPr>
          <p:cNvPr id="51" name="TextBox 50">
            <a:extLst>
              <a:ext uri="{FF2B5EF4-FFF2-40B4-BE49-F238E27FC236}">
                <a16:creationId xmlns:a16="http://schemas.microsoft.com/office/drawing/2014/main" id="{DF5F65B1-7698-09DB-28E4-1D38D6917406}"/>
              </a:ext>
            </a:extLst>
          </p:cNvPr>
          <p:cNvSpPr txBox="1"/>
          <p:nvPr/>
        </p:nvSpPr>
        <p:spPr>
          <a:xfrm>
            <a:off x="3594938" y="1807046"/>
            <a:ext cx="3996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3. Explain impact in fertility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34DD2EF0-9F2C-F1BA-DA1D-C029C7CFBD98}"/>
              </a:ext>
            </a:extLst>
          </p:cNvPr>
          <p:cNvCxnSpPr>
            <a:cxnSpLocks/>
          </p:cNvCxnSpPr>
          <p:nvPr/>
        </p:nvCxnSpPr>
        <p:spPr>
          <a:xfrm>
            <a:off x="3584764" y="2762038"/>
            <a:ext cx="400707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F594BA39-7911-C0FC-7E82-328E96AFB434}"/>
              </a:ext>
            </a:extLst>
          </p:cNvPr>
          <p:cNvSpPr txBox="1"/>
          <p:nvPr/>
        </p:nvSpPr>
        <p:spPr>
          <a:xfrm>
            <a:off x="3608149" y="2769411"/>
            <a:ext cx="3996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4. Rule out contraindications for GAHT</a:t>
            </a:r>
          </a:p>
        </p:txBody>
      </p:sp>
      <p:graphicFrame>
        <p:nvGraphicFramePr>
          <p:cNvPr id="57" name="Table 57">
            <a:extLst>
              <a:ext uri="{FF2B5EF4-FFF2-40B4-BE49-F238E27FC236}">
                <a16:creationId xmlns:a16="http://schemas.microsoft.com/office/drawing/2014/main" id="{93271CC8-450C-C28F-69F4-5B5F49087D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080007"/>
              </p:ext>
            </p:extLst>
          </p:nvPr>
        </p:nvGraphicFramePr>
        <p:xfrm>
          <a:off x="3665413" y="3051477"/>
          <a:ext cx="3863068" cy="96012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660349">
                  <a:extLst>
                    <a:ext uri="{9D8B030D-6E8A-4147-A177-3AD203B41FA5}">
                      <a16:colId xmlns:a16="http://schemas.microsoft.com/office/drawing/2014/main" val="2437805881"/>
                    </a:ext>
                  </a:extLst>
                </a:gridCol>
                <a:gridCol w="2202719">
                  <a:extLst>
                    <a:ext uri="{9D8B030D-6E8A-4147-A177-3AD203B41FA5}">
                      <a16:colId xmlns:a16="http://schemas.microsoft.com/office/drawing/2014/main" val="2053550807"/>
                    </a:ext>
                  </a:extLst>
                </a:gridCol>
              </a:tblGrid>
              <a:tr h="117383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chemeClr val="bg1"/>
                          </a:solidFill>
                        </a:rPr>
                        <a:t>Contraindications</a:t>
                      </a:r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chemeClr val="bg1"/>
                          </a:solidFill>
                        </a:rPr>
                        <a:t>Caution</a:t>
                      </a:r>
                    </a:p>
                  </a:txBody>
                  <a:tcPr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4451055"/>
                  </a:ext>
                </a:extLst>
              </a:tr>
              <a:tr h="270142">
                <a:tc>
                  <a:txBody>
                    <a:bodyPr/>
                    <a:lstStyle/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00" dirty="0"/>
                        <a:t>- Hx of hormone-sensitive cancer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00" dirty="0"/>
                        <a:t>- Acute psychotic episode</a:t>
                      </a:r>
                    </a:p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00" dirty="0"/>
                        <a:t>- Pregnancy</a:t>
                      </a:r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00" dirty="0"/>
                        <a:t>Mental illness that interferes w/ capacity to consent and F/U w/ care (cognitive impairment, severe SUD, psychosis)</a:t>
                      </a:r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0077635"/>
                  </a:ext>
                </a:extLst>
              </a:tr>
            </a:tbl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D520F000-6BF8-B742-1C2E-E5D3D0F8E6C1}"/>
              </a:ext>
            </a:extLst>
          </p:cNvPr>
          <p:cNvSpPr txBox="1"/>
          <p:nvPr/>
        </p:nvSpPr>
        <p:spPr>
          <a:xfrm>
            <a:off x="3577083" y="4088291"/>
            <a:ext cx="3996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5. Ensure health conditions stable &amp; well controlled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798F92D-5139-C8A1-1664-7D9476E31FB8}"/>
              </a:ext>
            </a:extLst>
          </p:cNvPr>
          <p:cNvSpPr txBox="1"/>
          <p:nvPr/>
        </p:nvSpPr>
        <p:spPr>
          <a:xfrm>
            <a:off x="3579986" y="565748"/>
            <a:ext cx="4012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2b. Assess capacity to consent for GAHT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9F63594-AF2C-40BD-5FD8-9D45ED592125}"/>
              </a:ext>
            </a:extLst>
          </p:cNvPr>
          <p:cNvSpPr txBox="1"/>
          <p:nvPr/>
        </p:nvSpPr>
        <p:spPr>
          <a:xfrm>
            <a:off x="3549294" y="4292912"/>
            <a:ext cx="408978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Mental health referral NOT required, but beneficial if aligned w/ pt goal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Treat co-occurring chronic and mental illness concomitantly with GAH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Do NOT discontinue GAHT unless contraindic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Assess comorbidities (CV risk factors, smoking, OSA, polycythemia)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6778C3FC-9405-3AF7-AC2E-620C77303DBA}"/>
              </a:ext>
            </a:extLst>
          </p:cNvPr>
          <p:cNvCxnSpPr>
            <a:cxnSpLocks/>
          </p:cNvCxnSpPr>
          <p:nvPr/>
        </p:nvCxnSpPr>
        <p:spPr>
          <a:xfrm>
            <a:off x="3595302" y="5047897"/>
            <a:ext cx="399704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480FD29F-69CC-07F3-F774-75CF4317062C}"/>
              </a:ext>
            </a:extLst>
          </p:cNvPr>
          <p:cNvSpPr txBox="1"/>
          <p:nvPr/>
        </p:nvSpPr>
        <p:spPr>
          <a:xfrm>
            <a:off x="3595449" y="5081826"/>
            <a:ext cx="3996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6. Get baseline lab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E51B18A-DC9E-BE99-8803-2FAF50B180A8}"/>
              </a:ext>
            </a:extLst>
          </p:cNvPr>
          <p:cNvSpPr txBox="1"/>
          <p:nvPr/>
        </p:nvSpPr>
        <p:spPr>
          <a:xfrm>
            <a:off x="3733802" y="5660694"/>
            <a:ext cx="2048356" cy="400110"/>
          </a:xfrm>
          <a:prstGeom prst="rect">
            <a:avLst/>
          </a:prstGeom>
          <a:solidFill>
            <a:srgbClr val="CE9BEF"/>
          </a:solidFill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strogen-based therapy</a:t>
            </a:r>
            <a:r>
              <a:rPr lang="en-US" sz="10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estradiol, BMP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06F4DC1-954E-9B77-02E5-3252414D1033}"/>
              </a:ext>
            </a:extLst>
          </p:cNvPr>
          <p:cNvSpPr txBox="1"/>
          <p:nvPr/>
        </p:nvSpPr>
        <p:spPr>
          <a:xfrm>
            <a:off x="5836079" y="5737638"/>
            <a:ext cx="1602114" cy="246222"/>
          </a:xfrm>
          <a:prstGeom prst="rect">
            <a:avLst/>
          </a:prstGeom>
          <a:solidFill>
            <a:srgbClr val="95459B"/>
          </a:solidFill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estosterone therapy</a:t>
            </a:r>
            <a:r>
              <a:rPr lang="en-US" sz="10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H/H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FD2C39B-9864-5223-C341-6A0D7D643E4D}"/>
              </a:ext>
            </a:extLst>
          </p:cNvPr>
          <p:cNvSpPr txBox="1"/>
          <p:nvPr/>
        </p:nvSpPr>
        <p:spPr>
          <a:xfrm>
            <a:off x="7573980" y="570603"/>
            <a:ext cx="4630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7. Prescribe GAHT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AE10EF8-09DF-1E7F-0E2D-A2A6C4D4E83F}"/>
              </a:ext>
            </a:extLst>
          </p:cNvPr>
          <p:cNvSpPr txBox="1"/>
          <p:nvPr/>
        </p:nvSpPr>
        <p:spPr>
          <a:xfrm>
            <a:off x="7594992" y="4952808"/>
            <a:ext cx="4596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8. Follow up appointments and monitoring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2CEF4EF-4BB0-326A-6CF2-490A9E86BBF6}"/>
              </a:ext>
            </a:extLst>
          </p:cNvPr>
          <p:cNvSpPr txBox="1"/>
          <p:nvPr/>
        </p:nvSpPr>
        <p:spPr>
          <a:xfrm>
            <a:off x="7601518" y="6141760"/>
            <a:ext cx="461802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cs typeface="Calibri"/>
              </a:rPr>
              <a:t>Year 1, </a:t>
            </a:r>
            <a:r>
              <a:rPr lang="en-US" sz="1000" b="1" dirty="0">
                <a:cs typeface="Calibri"/>
              </a:rPr>
              <a:t>Q3-month</a:t>
            </a:r>
            <a:r>
              <a:rPr lang="en-US" sz="1000" dirty="0">
                <a:cs typeface="Calibri"/>
              </a:rPr>
              <a:t> labs for GAHT titration </a:t>
            </a:r>
            <a:r>
              <a:rPr lang="en-US" sz="1000" b="1" dirty="0">
                <a:cs typeface="Calibri"/>
              </a:rPr>
              <a:t>until target</a:t>
            </a:r>
            <a:r>
              <a:rPr lang="en-US" sz="1000" dirty="0">
                <a:cs typeface="Calibri"/>
              </a:rPr>
              <a:t> reached: </a:t>
            </a:r>
            <a:r>
              <a:rPr lang="en-US" sz="1000" dirty="0">
                <a:ea typeface="+mn-lt"/>
                <a:cs typeface="Calibri"/>
              </a:rPr>
              <a:t>obtain hormones + BMP or K</a:t>
            </a:r>
            <a:r>
              <a:rPr lang="en-US" sz="1000" baseline="30000" dirty="0">
                <a:ea typeface="+mn-lt"/>
                <a:cs typeface="Calibri"/>
              </a:rPr>
              <a:t>+</a:t>
            </a:r>
            <a:r>
              <a:rPr lang="en-US" sz="1000" dirty="0">
                <a:ea typeface="+mn-lt"/>
                <a:cs typeface="Calibri"/>
              </a:rPr>
              <a:t> (estrogen-based), H/H (testosterone). </a:t>
            </a:r>
            <a:r>
              <a:rPr lang="en-US" sz="1000" u="sng" dirty="0">
                <a:ea typeface="+mn-lt"/>
                <a:cs typeface="Calibri"/>
              </a:rPr>
              <a:t>Once target reached, yearly visit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cs typeface="Calibri"/>
              </a:rPr>
              <a:t>Higher levels </a:t>
            </a:r>
            <a:r>
              <a:rPr lang="en-US" sz="1000" b="1" dirty="0">
                <a:cs typeface="Calibri"/>
              </a:rPr>
              <a:t>DO NOT </a:t>
            </a:r>
            <a:r>
              <a:rPr lang="en-US" sz="1000" dirty="0">
                <a:cs typeface="Calibri"/>
              </a:rPr>
              <a:t>result in higher degree of masculinization/feminiz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ea typeface="+mn-lt"/>
                <a:cs typeface="Calibri"/>
              </a:rPr>
              <a:t>Ranges can vary per your local lab</a:t>
            </a:r>
          </a:p>
        </p:txBody>
      </p:sp>
      <p:graphicFrame>
        <p:nvGraphicFramePr>
          <p:cNvPr id="42" name="Table 4">
            <a:extLst>
              <a:ext uri="{FF2B5EF4-FFF2-40B4-BE49-F238E27FC236}">
                <a16:creationId xmlns:a16="http://schemas.microsoft.com/office/drawing/2014/main" id="{66A0F2AA-0217-2B97-CF69-6BEE64E3C5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2878364"/>
              </p:ext>
            </p:extLst>
          </p:nvPr>
        </p:nvGraphicFramePr>
        <p:xfrm>
          <a:off x="7696629" y="3481488"/>
          <a:ext cx="4398668" cy="1408016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953911">
                  <a:extLst>
                    <a:ext uri="{9D8B030D-6E8A-4147-A177-3AD203B41FA5}">
                      <a16:colId xmlns:a16="http://schemas.microsoft.com/office/drawing/2014/main" val="2357645927"/>
                    </a:ext>
                  </a:extLst>
                </a:gridCol>
                <a:gridCol w="3444757">
                  <a:extLst>
                    <a:ext uri="{9D8B030D-6E8A-4147-A177-3AD203B41FA5}">
                      <a16:colId xmlns:a16="http://schemas.microsoft.com/office/drawing/2014/main" val="1818130877"/>
                    </a:ext>
                  </a:extLst>
                </a:gridCol>
              </a:tblGrid>
              <a:tr h="19405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chemeClr val="bg1"/>
                          </a:solidFill>
                        </a:rPr>
                        <a:t>GAHT</a:t>
                      </a:r>
                    </a:p>
                  </a:txBody>
                  <a:tcPr marL="81493" marR="81493" marT="40747" marB="40747"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chemeClr val="bg1"/>
                          </a:solidFill>
                        </a:rPr>
                        <a:t>Side effects</a:t>
                      </a:r>
                    </a:p>
                  </a:txBody>
                  <a:tcPr marL="81493" marR="81493" marT="40747" marB="40747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852648194"/>
                  </a:ext>
                </a:extLst>
              </a:tr>
              <a:tr h="419588">
                <a:tc>
                  <a:txBody>
                    <a:bodyPr/>
                    <a:lstStyle/>
                    <a:p>
                      <a:r>
                        <a:rPr lang="en-US" sz="1000" dirty="0"/>
                        <a:t>Estrogen</a:t>
                      </a:r>
                    </a:p>
                  </a:txBody>
                  <a:tcPr marL="81493" marR="81493" marT="40747" marB="40747">
                    <a:lnR w="3175" cap="flat" cmpd="sng" algn="ctr">
                      <a:solidFill>
                        <a:srgbClr val="95459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- VTE, HyperTG, weight gain, migraine, cholelithiasi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- No increased risk of HTN, T2DM, osteoporosis, hyperprolactinemia; mixed findings on CVD impact</a:t>
                      </a:r>
                    </a:p>
                  </a:txBody>
                  <a:tcPr marL="81493" marR="81493" marT="40747" marB="40747">
                    <a:lnL w="3175" cap="flat" cmpd="sng" algn="ctr">
                      <a:solidFill>
                        <a:srgbClr val="95459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4232635247"/>
                  </a:ext>
                </a:extLst>
              </a:tr>
              <a:tr h="182180">
                <a:tc>
                  <a:txBody>
                    <a:bodyPr/>
                    <a:lstStyle/>
                    <a:p>
                      <a:r>
                        <a:rPr lang="en-US" sz="1000" dirty="0"/>
                        <a:t>Spironolactone</a:t>
                      </a:r>
                    </a:p>
                  </a:txBody>
                  <a:tcPr marL="81493" marR="81493" marT="40747" marB="40747">
                    <a:lnR w="3175" cap="flat" cmpd="sng" algn="ctr">
                      <a:solidFill>
                        <a:srgbClr val="95459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- Hyperkalemia, hypotension, frequency, polyuria, polydipsia</a:t>
                      </a:r>
                    </a:p>
                  </a:txBody>
                  <a:tcPr marL="81493" marR="81493" marT="40747" marB="40747">
                    <a:lnL w="3175" cap="flat" cmpd="sng" algn="ctr">
                      <a:solidFill>
                        <a:srgbClr val="95459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186595386"/>
                  </a:ext>
                </a:extLst>
              </a:tr>
              <a:tr h="325029">
                <a:tc>
                  <a:txBody>
                    <a:bodyPr/>
                    <a:lstStyle/>
                    <a:p>
                      <a:r>
                        <a:rPr lang="en-US" sz="1000" dirty="0"/>
                        <a:t>Testosterone</a:t>
                      </a:r>
                    </a:p>
                  </a:txBody>
                  <a:tcPr marL="81493" marR="81493" marT="40747" marB="40747">
                    <a:lnR w="3175" cap="flat" cmpd="sng" algn="ctr">
                      <a:solidFill>
                        <a:srgbClr val="95459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- Polycythemia, HTN, weight gain, increased LDL and LFTs, decreased HDL; mixed findings on CVD impact</a:t>
                      </a:r>
                    </a:p>
                  </a:txBody>
                  <a:tcPr marL="81493" marR="81493" marT="40747" marB="40747">
                    <a:lnL w="3175" cap="flat" cmpd="sng" algn="ctr">
                      <a:solidFill>
                        <a:srgbClr val="95459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991425282"/>
                  </a:ext>
                </a:extLst>
              </a:tr>
            </a:tbl>
          </a:graphicData>
        </a:graphic>
      </p:graphicFrame>
      <p:sp>
        <p:nvSpPr>
          <p:cNvPr id="82" name="TextBox 81">
            <a:extLst>
              <a:ext uri="{FF2B5EF4-FFF2-40B4-BE49-F238E27FC236}">
                <a16:creationId xmlns:a16="http://schemas.microsoft.com/office/drawing/2014/main" id="{7A56CD48-85CE-4FE8-3671-EABA79EAE5F9}"/>
              </a:ext>
            </a:extLst>
          </p:cNvPr>
          <p:cNvSpPr txBox="1"/>
          <p:nvPr/>
        </p:nvSpPr>
        <p:spPr>
          <a:xfrm>
            <a:off x="5740" y="561852"/>
            <a:ext cx="3582242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2475"/>
                </a:solidFill>
                <a:latin typeface="Helvetica" pitchFamily="2" charset="0"/>
              </a:rPr>
              <a:t>1. Assess and document gender dysphoria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8512916F-C986-CC42-A55A-011D7A1106FE}"/>
              </a:ext>
            </a:extLst>
          </p:cNvPr>
          <p:cNvCxnSpPr>
            <a:cxnSpLocks/>
          </p:cNvCxnSpPr>
          <p:nvPr/>
        </p:nvCxnSpPr>
        <p:spPr>
          <a:xfrm>
            <a:off x="3576936" y="1823156"/>
            <a:ext cx="399704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A916C13E-3C4C-8AEF-0B8A-A8D84F24CC61}"/>
              </a:ext>
            </a:extLst>
          </p:cNvPr>
          <p:cNvSpPr txBox="1"/>
          <p:nvPr/>
        </p:nvSpPr>
        <p:spPr>
          <a:xfrm>
            <a:off x="-4163" y="777499"/>
            <a:ext cx="358222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ea typeface="+mn-lt"/>
                <a:cs typeface="+mn-lt"/>
              </a:rPr>
              <a:t>- Incongruence between sex and gender, resulting in </a:t>
            </a:r>
            <a:r>
              <a:rPr lang="en-US" sz="1000" b="1" dirty="0">
                <a:ea typeface="+mn-lt"/>
                <a:cs typeface="+mn-lt"/>
              </a:rPr>
              <a:t>distress or social/occupational impairment </a:t>
            </a:r>
            <a:r>
              <a:rPr lang="en-US" sz="1000" dirty="0">
                <a:ea typeface="+mn-lt"/>
                <a:cs typeface="+mn-lt"/>
              </a:rPr>
              <a:t>for at least </a:t>
            </a:r>
            <a:r>
              <a:rPr lang="en-US" sz="1000" u="sng" dirty="0">
                <a:ea typeface="+mn-lt"/>
                <a:cs typeface="+mn-lt"/>
              </a:rPr>
              <a:t>6 months</a:t>
            </a:r>
            <a:endParaRPr lang="en-US" sz="1000" b="1" u="sng" dirty="0">
              <a:ea typeface="+mn-lt"/>
              <a:cs typeface="+mn-lt"/>
            </a:endParaRPr>
          </a:p>
          <a:p>
            <a:r>
              <a:rPr lang="en-US" sz="1000" dirty="0">
                <a:ea typeface="+mn-lt"/>
                <a:cs typeface="+mn-lt"/>
              </a:rPr>
              <a:t>- Desire: to be (and be treated as) another gender, for sex characteristics of another gender, to get rid of sex characteristics</a:t>
            </a:r>
          </a:p>
          <a:p>
            <a:r>
              <a:rPr lang="en-US" sz="1000" dirty="0">
                <a:ea typeface="+mn-lt"/>
                <a:cs typeface="+mn-lt"/>
              </a:rPr>
              <a:t>- There can be gender incongruence w/o dysphoria, ok for GAHT</a:t>
            </a:r>
          </a:p>
          <a:p>
            <a:endParaRPr lang="en-US" sz="1000" dirty="0">
              <a:ea typeface="+mn-lt"/>
              <a:cs typeface="+mn-lt"/>
            </a:endParaRP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73D975C5-6038-AD73-6D0E-CFB3DE14905C}"/>
              </a:ext>
            </a:extLst>
          </p:cNvPr>
          <p:cNvCxnSpPr>
            <a:cxnSpLocks/>
          </p:cNvCxnSpPr>
          <p:nvPr/>
        </p:nvCxnSpPr>
        <p:spPr>
          <a:xfrm>
            <a:off x="-4163" y="1663924"/>
            <a:ext cx="358554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7BDD7C7C-E341-13B4-A193-1032D2EC8C26}"/>
              </a:ext>
            </a:extLst>
          </p:cNvPr>
          <p:cNvSpPr txBox="1"/>
          <p:nvPr/>
        </p:nvSpPr>
        <p:spPr>
          <a:xfrm>
            <a:off x="3586366" y="796589"/>
            <a:ext cx="399575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ea typeface="+mn-lt"/>
                <a:cs typeface="+mn-lt"/>
              </a:rPr>
              <a:t>- “Informed consent” model: ensure patient understands and agrees with expected physical changes, impact in fertility, possible side effects of GAHT, required follow-up, unknowns, limitations, social impact</a:t>
            </a:r>
          </a:p>
          <a:p>
            <a:r>
              <a:rPr lang="en-US" sz="1000" dirty="0">
                <a:ea typeface="+mn-lt"/>
                <a:cs typeface="+mn-lt"/>
              </a:rPr>
              <a:t>- </a:t>
            </a:r>
            <a:r>
              <a:rPr lang="en-US" sz="1000" b="1" dirty="0">
                <a:ea typeface="+mn-lt"/>
                <a:cs typeface="+mn-lt"/>
              </a:rPr>
              <a:t>NO regimen</a:t>
            </a:r>
            <a:r>
              <a:rPr lang="en-US" sz="1000" dirty="0">
                <a:ea typeface="+mn-lt"/>
                <a:cs typeface="+mn-lt"/>
              </a:rPr>
              <a:t> </a:t>
            </a:r>
            <a:r>
              <a:rPr lang="en-US" sz="1000" b="1" dirty="0">
                <a:ea typeface="+mn-lt"/>
                <a:cs typeface="+mn-lt"/>
              </a:rPr>
              <a:t>can predict </a:t>
            </a:r>
            <a:r>
              <a:rPr lang="en-US" sz="1000" dirty="0">
                <a:ea typeface="+mn-lt"/>
                <a:cs typeface="+mn-lt"/>
              </a:rPr>
              <a:t>specific sex characteristics and the </a:t>
            </a:r>
            <a:r>
              <a:rPr lang="en-US" sz="1000" b="1" dirty="0">
                <a:ea typeface="+mn-lt"/>
                <a:cs typeface="+mn-lt"/>
              </a:rPr>
              <a:t>timeline is different for EVERYONE</a:t>
            </a:r>
            <a:r>
              <a:rPr lang="en-US" sz="1000" dirty="0">
                <a:ea typeface="+mn-lt"/>
                <a:cs typeface="+mn-lt"/>
              </a:rPr>
              <a:t> (typically max effect is 2-5 years after onset)</a:t>
            </a:r>
          </a:p>
          <a:p>
            <a:r>
              <a:rPr lang="en-US" sz="1000" dirty="0">
                <a:ea typeface="+mn-lt"/>
                <a:cs typeface="+mn-lt"/>
              </a:rPr>
              <a:t>- Some pts have personalized goals. Ok as long as within standards of care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A7A88C2-A0CA-30AF-FAF9-D07D59503A1B}"/>
              </a:ext>
            </a:extLst>
          </p:cNvPr>
          <p:cNvSpPr txBox="1"/>
          <p:nvPr/>
        </p:nvSpPr>
        <p:spPr>
          <a:xfrm>
            <a:off x="4894499" y="5367860"/>
            <a:ext cx="1424195" cy="246222"/>
          </a:xfrm>
          <a:prstGeom prst="rect">
            <a:avLst/>
          </a:prstGeom>
          <a:solidFill>
            <a:srgbClr val="928DDA"/>
          </a:solidFill>
        </p:spPr>
        <p:txBody>
          <a:bodyPr wrap="square">
            <a:spAutoFit/>
          </a:bodyPr>
          <a:lstStyle/>
          <a:p>
            <a:pPr algn="ctr"/>
            <a:r>
              <a:rPr lang="en-US" sz="1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ll:</a:t>
            </a:r>
            <a:r>
              <a:rPr lang="en-US" sz="10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Total testosterone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162445BF-FE40-0F04-FF32-3CE81CDB6E91}"/>
              </a:ext>
            </a:extLst>
          </p:cNvPr>
          <p:cNvSpPr txBox="1"/>
          <p:nvPr/>
        </p:nvSpPr>
        <p:spPr>
          <a:xfrm>
            <a:off x="114907" y="6578227"/>
            <a:ext cx="325173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Calibri" panose="020F0502020204030204" pitchFamily="34" charset="0"/>
                <a:cs typeface="Calibri" panose="020F0502020204030204" pitchFamily="34" charset="0"/>
              </a:rPr>
              <a:t>Bolded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 are irreversible chang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0B465EB-A2EB-0FEE-4F2A-A4FC87DEAD95}"/>
              </a:ext>
            </a:extLst>
          </p:cNvPr>
          <p:cNvSpPr txBox="1"/>
          <p:nvPr/>
        </p:nvSpPr>
        <p:spPr>
          <a:xfrm>
            <a:off x="3549294" y="6095706"/>
            <a:ext cx="408978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Baseline and follow up lab practices may vary across institution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Testosterone levels are needed as some individuals may conditions that may affect dosing to achieve therapeutic level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b="1" dirty="0">
                <a:latin typeface="Calibri" panose="020F0502020204030204" pitchFamily="34" charset="0"/>
                <a:cs typeface="Calibri" panose="020F0502020204030204" pitchFamily="34" charset="0"/>
              </a:rPr>
              <a:t>H/H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: reference ranges are based on the hormone being prescribe</a:t>
            </a:r>
          </a:p>
        </p:txBody>
      </p:sp>
    </p:spTree>
    <p:extLst>
      <p:ext uri="{BB962C8B-B14F-4D97-AF65-F5344CB8AC3E}">
        <p14:creationId xmlns:p14="http://schemas.microsoft.com/office/powerpoint/2010/main" val="1898814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rans Health 2">
      <a:dk1>
        <a:srgbClr val="000000"/>
      </a:dk1>
      <a:lt1>
        <a:srgbClr val="FFFFFF"/>
      </a:lt1>
      <a:dk2>
        <a:srgbClr val="454551"/>
      </a:dk2>
      <a:lt2>
        <a:srgbClr val="D8D9DC"/>
      </a:lt2>
      <a:accent1>
        <a:srgbClr val="95459B"/>
      </a:accent1>
      <a:accent2>
        <a:srgbClr val="95459B"/>
      </a:accent2>
      <a:accent3>
        <a:srgbClr val="A75AE1"/>
      </a:accent3>
      <a:accent4>
        <a:srgbClr val="720781"/>
      </a:accent4>
      <a:accent5>
        <a:srgbClr val="CE9CEE"/>
      </a:accent5>
      <a:accent6>
        <a:srgbClr val="DBBBF2"/>
      </a:accent6>
      <a:hlink>
        <a:srgbClr val="740884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060</TotalTime>
  <Words>976</Words>
  <Application>Microsoft Macintosh PowerPoint</Application>
  <PresentationFormat>Widescreen</PresentationFormat>
  <Paragraphs>1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bastian Suarez Zarate</dc:creator>
  <cp:lastModifiedBy>Sebastian Suarez</cp:lastModifiedBy>
  <cp:revision>1</cp:revision>
  <dcterms:created xsi:type="dcterms:W3CDTF">2023-01-09T17:38:44Z</dcterms:created>
  <dcterms:modified xsi:type="dcterms:W3CDTF">2025-01-07T22:01:18Z</dcterms:modified>
</cp:coreProperties>
</file>